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98" r:id="rId2"/>
    <p:sldId id="309" r:id="rId3"/>
    <p:sldId id="315" r:id="rId4"/>
    <p:sldId id="299" r:id="rId5"/>
  </p:sldIdLst>
  <p:sldSz cx="12192000" cy="6858000"/>
  <p:notesSz cx="6865938" cy="999807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195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D86FF"/>
    <a:srgbClr val="DF0011"/>
    <a:srgbClr val="006A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828" autoAdjust="0"/>
    <p:restoredTop sz="96383" autoAdjust="0"/>
  </p:normalViewPr>
  <p:slideViewPr>
    <p:cSldViewPr snapToGrid="0">
      <p:cViewPr varScale="1">
        <p:scale>
          <a:sx n="74" d="100"/>
          <a:sy n="74" d="100"/>
        </p:scale>
        <p:origin x="-912" y="-90"/>
      </p:cViewPr>
      <p:guideLst>
        <p:guide orient="horz" pos="2160"/>
        <p:guide pos="195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5240" cy="501640"/>
          </a:xfrm>
          <a:prstGeom prst="rect">
            <a:avLst/>
          </a:prstGeom>
        </p:spPr>
        <p:txBody>
          <a:bodyPr vert="horz" lIns="96359" tIns="48180" rIns="96359" bIns="48180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9109" y="0"/>
            <a:ext cx="2975240" cy="501640"/>
          </a:xfrm>
          <a:prstGeom prst="rect">
            <a:avLst/>
          </a:prstGeom>
        </p:spPr>
        <p:txBody>
          <a:bodyPr vert="horz" lIns="96359" tIns="48180" rIns="96359" bIns="48180" rtlCol="0"/>
          <a:lstStyle>
            <a:lvl1pPr algn="r">
              <a:defRPr sz="1300"/>
            </a:lvl1pPr>
          </a:lstStyle>
          <a:p>
            <a:fld id="{AD04CE83-272B-4F54-9A2E-622888DFD1BD}" type="datetimeFigureOut">
              <a:rPr lang="ko-KR" altLang="en-US" smtClean="0"/>
              <a:t>2021-05-2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434975" y="1249363"/>
            <a:ext cx="5997575" cy="33750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359" tIns="48180" rIns="96359" bIns="4818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6594" y="4811574"/>
            <a:ext cx="5492750" cy="3936742"/>
          </a:xfrm>
          <a:prstGeom prst="rect">
            <a:avLst/>
          </a:prstGeom>
        </p:spPr>
        <p:txBody>
          <a:bodyPr vert="horz" lIns="96359" tIns="48180" rIns="96359" bIns="4818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96437"/>
            <a:ext cx="2975240" cy="501639"/>
          </a:xfrm>
          <a:prstGeom prst="rect">
            <a:avLst/>
          </a:prstGeom>
        </p:spPr>
        <p:txBody>
          <a:bodyPr vert="horz" lIns="96359" tIns="48180" rIns="96359" bIns="48180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9109" y="9496437"/>
            <a:ext cx="2975240" cy="501639"/>
          </a:xfrm>
          <a:prstGeom prst="rect">
            <a:avLst/>
          </a:prstGeom>
        </p:spPr>
        <p:txBody>
          <a:bodyPr vert="horz" lIns="96359" tIns="48180" rIns="96359" bIns="48180" rtlCol="0" anchor="b"/>
          <a:lstStyle>
            <a:lvl1pPr algn="r">
              <a:defRPr sz="1300"/>
            </a:lvl1pPr>
          </a:lstStyle>
          <a:p>
            <a:fld id="{F0A79D55-954B-4965-958D-55D01A1F73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63870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FE185-E331-4502-B2A4-4E1BE6480188}" type="datetimeFigureOut">
              <a:rPr lang="ko-KR" altLang="en-US" smtClean="0"/>
              <a:t>2021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40CCE-C6FA-4DAA-A493-B919BE872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69051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FE185-E331-4502-B2A4-4E1BE6480188}" type="datetimeFigureOut">
              <a:rPr lang="ko-KR" altLang="en-US" smtClean="0"/>
              <a:t>2021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40CCE-C6FA-4DAA-A493-B919BE872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81074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FE185-E331-4502-B2A4-4E1BE6480188}" type="datetimeFigureOut">
              <a:rPr lang="ko-KR" altLang="en-US" smtClean="0"/>
              <a:t>2021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40CCE-C6FA-4DAA-A493-B919BE872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05733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FE185-E331-4502-B2A4-4E1BE6480188}" type="datetimeFigureOut">
              <a:rPr lang="ko-KR" altLang="en-US" smtClean="0"/>
              <a:t>2021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40CCE-C6FA-4DAA-A493-B919BE872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308911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FE185-E331-4502-B2A4-4E1BE6480188}" type="datetimeFigureOut">
              <a:rPr lang="ko-KR" altLang="en-US" smtClean="0"/>
              <a:t>2021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40CCE-C6FA-4DAA-A493-B919BE872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06928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FE185-E331-4502-B2A4-4E1BE6480188}" type="datetimeFigureOut">
              <a:rPr lang="ko-KR" altLang="en-US" smtClean="0"/>
              <a:t>2021-05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40CCE-C6FA-4DAA-A493-B919BE872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16295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FE185-E331-4502-B2A4-4E1BE6480188}" type="datetimeFigureOut">
              <a:rPr lang="ko-KR" altLang="en-US" smtClean="0"/>
              <a:t>2021-05-2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40CCE-C6FA-4DAA-A493-B919BE872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938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FE185-E331-4502-B2A4-4E1BE6480188}" type="datetimeFigureOut">
              <a:rPr lang="ko-KR" altLang="en-US" smtClean="0"/>
              <a:t>2021-05-2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40CCE-C6FA-4DAA-A493-B919BE872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09217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FE185-E331-4502-B2A4-4E1BE6480188}" type="datetimeFigureOut">
              <a:rPr lang="ko-KR" altLang="en-US" smtClean="0"/>
              <a:t>2021-05-2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40CCE-C6FA-4DAA-A493-B919BE872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409440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FE185-E331-4502-B2A4-4E1BE6480188}" type="datetimeFigureOut">
              <a:rPr lang="ko-KR" altLang="en-US" smtClean="0"/>
              <a:t>2021-05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40CCE-C6FA-4DAA-A493-B919BE872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01372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FE185-E331-4502-B2A4-4E1BE6480188}" type="datetimeFigureOut">
              <a:rPr lang="ko-KR" altLang="en-US" smtClean="0"/>
              <a:t>2021-05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40CCE-C6FA-4DAA-A493-B919BE872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511760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7FE185-E331-4502-B2A4-4E1BE6480188}" type="datetimeFigureOut">
              <a:rPr lang="ko-KR" altLang="en-US" smtClean="0"/>
              <a:t>2021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C40CCE-C6FA-4DAA-A493-B919BE872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526548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jpg"/><Relationship Id="rId3" Type="http://schemas.openxmlformats.org/officeDocument/2006/relationships/image" Target="../media/image6.jpg"/><Relationship Id="rId7" Type="http://schemas.openxmlformats.org/officeDocument/2006/relationships/image" Target="../media/image10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jpg"/><Relationship Id="rId5" Type="http://schemas.openxmlformats.org/officeDocument/2006/relationships/image" Target="../media/image8.jpeg"/><Relationship Id="rId10" Type="http://schemas.microsoft.com/office/2007/relationships/hdphoto" Target="../media/hdphoto5.wdp"/><Relationship Id="rId4" Type="http://schemas.openxmlformats.org/officeDocument/2006/relationships/image" Target="../media/image7.jpg"/><Relationship Id="rId9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13" Type="http://schemas.microsoft.com/office/2007/relationships/hdphoto" Target="../media/hdphoto11.wdp"/><Relationship Id="rId3" Type="http://schemas.microsoft.com/office/2007/relationships/hdphoto" Target="../media/hdphoto6.wdp"/><Relationship Id="rId7" Type="http://schemas.microsoft.com/office/2007/relationships/hdphoto" Target="../media/hdphoto8.wdp"/><Relationship Id="rId12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11" Type="http://schemas.microsoft.com/office/2007/relationships/hdphoto" Target="../media/hdphoto10.wdp"/><Relationship Id="rId5" Type="http://schemas.microsoft.com/office/2007/relationships/hdphoto" Target="../media/hdphoto7.wdp"/><Relationship Id="rId10" Type="http://schemas.openxmlformats.org/officeDocument/2006/relationships/image" Target="../media/image17.png"/><Relationship Id="rId4" Type="http://schemas.openxmlformats.org/officeDocument/2006/relationships/image" Target="../media/image14.png"/><Relationship Id="rId9" Type="http://schemas.microsoft.com/office/2007/relationships/hdphoto" Target="../media/hdphoto9.wdp"/><Relationship Id="rId14" Type="http://schemas.openxmlformats.org/officeDocument/2006/relationships/image" Target="../media/image1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표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11223593"/>
              </p:ext>
            </p:extLst>
          </p:nvPr>
        </p:nvGraphicFramePr>
        <p:xfrm>
          <a:off x="4279525" y="990899"/>
          <a:ext cx="3632950" cy="5317788"/>
        </p:xfrm>
        <a:graphic>
          <a:graphicData uri="http://schemas.openxmlformats.org/drawingml/2006/table">
            <a:tbl>
              <a:tblPr/>
              <a:tblGrid>
                <a:gridCol w="3632950">
                  <a:extLst>
                    <a:ext uri="{9D8B030D-6E8A-4147-A177-3AD203B41FA5}">
                      <a16:colId xmlns:a16="http://schemas.microsoft.com/office/drawing/2014/main" xmlns="" val="2592388975"/>
                    </a:ext>
                  </a:extLst>
                </a:gridCol>
              </a:tblGrid>
              <a:tr h="1549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exadecanoic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 acid</a:t>
                      </a: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304287150"/>
                  </a:ext>
                </a:extLst>
              </a:tr>
              <a:tr h="1549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atechol</a:t>
                      </a: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93182033"/>
                  </a:ext>
                </a:extLst>
              </a:tr>
              <a:tr h="1549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Triamterene</a:t>
                      </a: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42037377"/>
                  </a:ext>
                </a:extLst>
              </a:tr>
              <a:tr h="1549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enadio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26543523"/>
                  </a:ext>
                </a:extLst>
              </a:tr>
              <a:tr h="1549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-(+)-Xylose</a:t>
                      </a: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26341440"/>
                  </a:ext>
                </a:extLst>
              </a:tr>
              <a:tr h="1549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-Methylcatechol</a:t>
                      </a: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86395738"/>
                  </a:ext>
                </a:extLst>
              </a:tr>
              <a:tr h="1549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ydroquinone</a:t>
                      </a: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80524907"/>
                  </a:ext>
                </a:extLst>
              </a:tr>
              <a:tr h="16194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′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-Deoxyguanosine</a:t>
                      </a: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35060391"/>
                  </a:ext>
                </a:extLst>
              </a:tr>
              <a:tr h="1549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llyl Methyl Sulfide</a:t>
                      </a: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37249908"/>
                  </a:ext>
                </a:extLst>
              </a:tr>
              <a:tr h="1549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ydrochlorothiazide</a:t>
                      </a: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40168551"/>
                  </a:ext>
                </a:extLst>
              </a:tr>
              <a:tr h="1549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Xanthurenic acid</a:t>
                      </a: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3428181"/>
                  </a:ext>
                </a:extLst>
              </a:tr>
              <a:tr h="1549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-(5'-Adenosyl)-L-methionine p-toluenesulfonate salt</a:t>
                      </a: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25911321"/>
                  </a:ext>
                </a:extLst>
              </a:tr>
              <a:tr h="1549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-Methyltyramine HCl</a:t>
                      </a: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90737037"/>
                  </a:ext>
                </a:extLst>
              </a:tr>
              <a:tr h="1549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(±)-Naringenin</a:t>
                      </a: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78294050"/>
                  </a:ext>
                </a:extLst>
              </a:tr>
              <a:tr h="1549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almitoleic Acid</a:t>
                      </a: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69832451"/>
                  </a:ext>
                </a:extLst>
              </a:tr>
              <a:tr h="1549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-Hydroxy-3-methoxyphenylacetic Acid</a:t>
                      </a: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24594070"/>
                  </a:ext>
                </a:extLst>
              </a:tr>
              <a:tr h="1549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-Hexadecanol</a:t>
                      </a: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112285096"/>
                  </a:ext>
                </a:extLst>
              </a:tr>
              <a:tr h="1549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,11-Undecanedicarboxylic acid</a:t>
                      </a: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130817206"/>
                  </a:ext>
                </a:extLst>
              </a:tr>
              <a:tr h="1549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L-p-Hydroxyphenyllactic acid</a:t>
                      </a: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01737125"/>
                  </a:ext>
                </a:extLst>
              </a:tr>
              <a:tr h="1549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-hydroxybutyric acid</a:t>
                      </a: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15308197"/>
                  </a:ext>
                </a:extLst>
              </a:tr>
              <a:tr h="1549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n-glycero-3-Phosphocholine</a:t>
                      </a: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75928936"/>
                  </a:ext>
                </a:extLst>
              </a:tr>
              <a:tr h="1549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urfural</a:t>
                      </a: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347811"/>
                  </a:ext>
                </a:extLst>
              </a:tr>
              <a:tr h="1549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-Nitrophenol</a:t>
                      </a: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39693075"/>
                  </a:ext>
                </a:extLst>
              </a:tr>
              <a:tr h="1549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scorbic acid</a:t>
                      </a: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2102817"/>
                  </a:ext>
                </a:extLst>
              </a:tr>
              <a:tr h="1549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Tryptamine</a:t>
                      </a: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03666333"/>
                  </a:ext>
                </a:extLst>
              </a:tr>
              <a:tr h="1549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permidine</a:t>
                      </a: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47329227"/>
                  </a:ext>
                </a:extLst>
              </a:tr>
              <a:tr h="15490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eoxycholic acid</a:t>
                      </a: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70614180"/>
                  </a:ext>
                </a:extLst>
              </a:tr>
              <a:tr h="16194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,4-Dihydroxybenzeneacetic acid</a:t>
                      </a:r>
                    </a:p>
                  </a:txBody>
                  <a:tcPr marL="7041" marR="7041" marT="704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123902438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A2B79315-687B-473B-A4EB-B7D57EAEB7E0}"/>
              </a:ext>
            </a:extLst>
          </p:cNvPr>
          <p:cNvSpPr txBox="1"/>
          <p:nvPr/>
        </p:nvSpPr>
        <p:spPr>
          <a:xfrm>
            <a:off x="328639" y="312536"/>
            <a:ext cx="22733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Supplementary Figure 1.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4625887" y="661878"/>
            <a:ext cx="29402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List</a:t>
            </a:r>
            <a:r>
              <a:rPr lang="ko-KR" alt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of inducer of GFP-Gal3 punct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57257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7D404FAA-72E7-44BE-A80E-BDAD82545781}"/>
              </a:ext>
            </a:extLst>
          </p:cNvPr>
          <p:cNvSpPr txBox="1"/>
          <p:nvPr/>
        </p:nvSpPr>
        <p:spPr>
          <a:xfrm>
            <a:off x="328639" y="312536"/>
            <a:ext cx="22733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xmlns="" id="{CFC7A4E7-E473-4F8A-98D0-C0540859BED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598" r="33085"/>
          <a:stretch/>
        </p:blipFill>
        <p:spPr>
          <a:xfrm>
            <a:off x="4303256" y="3465165"/>
            <a:ext cx="432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xmlns="" id="{64F0E43D-8BEE-4427-9081-7FB605D9545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931" r="33145"/>
          <a:stretch/>
        </p:blipFill>
        <p:spPr>
          <a:xfrm>
            <a:off x="4303256" y="3177000"/>
            <a:ext cx="432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76AB0C89-F0DF-4734-AABE-5B76F40972CE}"/>
              </a:ext>
            </a:extLst>
          </p:cNvPr>
          <p:cNvSpPr txBox="1"/>
          <p:nvPr/>
        </p:nvSpPr>
        <p:spPr>
          <a:xfrm>
            <a:off x="4743681" y="3172195"/>
            <a:ext cx="561372" cy="261610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ATG5</a:t>
            </a:r>
            <a:endParaRPr lang="ko-KR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B459B438-98E6-46B5-B96A-75AF00B6C06D}"/>
              </a:ext>
            </a:extLst>
          </p:cNvPr>
          <p:cNvSpPr txBox="1"/>
          <p:nvPr/>
        </p:nvSpPr>
        <p:spPr>
          <a:xfrm>
            <a:off x="4743681" y="3468054"/>
            <a:ext cx="635110" cy="253916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ACTA1</a:t>
            </a:r>
            <a:endParaRPr lang="ko-KR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9B701204-CAA7-4D0A-81B6-5E77687CCCDD}"/>
              </a:ext>
            </a:extLst>
          </p:cNvPr>
          <p:cNvSpPr txBox="1"/>
          <p:nvPr/>
        </p:nvSpPr>
        <p:spPr>
          <a:xfrm rot="16200000">
            <a:off x="4235521" y="2860086"/>
            <a:ext cx="3577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  <a:endParaRPr lang="ko-KR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E2D49904-7FEB-4178-BF57-A3D3B79222CE}"/>
              </a:ext>
            </a:extLst>
          </p:cNvPr>
          <p:cNvSpPr txBox="1"/>
          <p:nvPr/>
        </p:nvSpPr>
        <p:spPr>
          <a:xfrm rot="16200000">
            <a:off x="4301952" y="2699785"/>
            <a:ext cx="67839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ATG5</a:t>
            </a:r>
            <a:endParaRPr lang="ko-KR" altLang="en-US" sz="105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그림 10">
            <a:extLst>
              <a:ext uri="{FF2B5EF4-FFF2-40B4-BE49-F238E27FC236}">
                <a16:creationId xmlns:a16="http://schemas.microsoft.com/office/drawing/2014/main" xmlns="" id="{922E7908-D102-4CB9-A9F5-9FA05C5501F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349" r="65094"/>
          <a:stretch/>
        </p:blipFill>
        <p:spPr>
          <a:xfrm>
            <a:off x="6753543" y="3465165"/>
            <a:ext cx="432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DEDE53CA-D069-438C-8D24-CDBCD08373C2}"/>
              </a:ext>
            </a:extLst>
          </p:cNvPr>
          <p:cNvSpPr txBox="1"/>
          <p:nvPr/>
        </p:nvSpPr>
        <p:spPr>
          <a:xfrm>
            <a:off x="7192686" y="3174634"/>
            <a:ext cx="764953" cy="261610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SQSTM1</a:t>
            </a:r>
            <a:endParaRPr lang="ko-KR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617AC43C-CCAC-4DED-957F-702F190513F1}"/>
              </a:ext>
            </a:extLst>
          </p:cNvPr>
          <p:cNvSpPr txBox="1"/>
          <p:nvPr/>
        </p:nvSpPr>
        <p:spPr>
          <a:xfrm>
            <a:off x="7192686" y="3468054"/>
            <a:ext cx="635110" cy="253916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ACTA1</a:t>
            </a:r>
            <a:endParaRPr lang="ko-KR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FCC05C33-3A67-4C0A-A03F-8DB202AC1547}"/>
              </a:ext>
            </a:extLst>
          </p:cNvPr>
          <p:cNvSpPr txBox="1"/>
          <p:nvPr/>
        </p:nvSpPr>
        <p:spPr>
          <a:xfrm rot="16200000">
            <a:off x="6686307" y="2860085"/>
            <a:ext cx="3577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  <a:endParaRPr lang="ko-KR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5BC92FE6-1864-48BD-AC54-8B1DEA5EC35F}"/>
              </a:ext>
            </a:extLst>
          </p:cNvPr>
          <p:cNvSpPr txBox="1"/>
          <p:nvPr/>
        </p:nvSpPr>
        <p:spPr>
          <a:xfrm rot="16200000">
            <a:off x="6627931" y="2597993"/>
            <a:ext cx="8819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SQSTM1</a:t>
            </a:r>
            <a:endParaRPr lang="ko-KR" altLang="en-US" sz="105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그림 15">
            <a:extLst>
              <a:ext uri="{FF2B5EF4-FFF2-40B4-BE49-F238E27FC236}">
                <a16:creationId xmlns:a16="http://schemas.microsoft.com/office/drawing/2014/main" xmlns="" id="{F173640A-9AFB-4642-B942-5851B2D83C5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782" r="65551"/>
          <a:stretch/>
        </p:blipFill>
        <p:spPr>
          <a:xfrm>
            <a:off x="6753543" y="3177000"/>
            <a:ext cx="432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EB993171-57BB-4397-9F3A-32C03895AD51}"/>
              </a:ext>
            </a:extLst>
          </p:cNvPr>
          <p:cNvSpPr txBox="1"/>
          <p:nvPr/>
        </p:nvSpPr>
        <p:spPr>
          <a:xfrm>
            <a:off x="3775060" y="246291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85839F2B-7A38-4B1C-9C1F-89CCFE59FE63}"/>
              </a:ext>
            </a:extLst>
          </p:cNvPr>
          <p:cNvSpPr txBox="1"/>
          <p:nvPr/>
        </p:nvSpPr>
        <p:spPr>
          <a:xfrm>
            <a:off x="6215776" y="246291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19087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7D404FAA-72E7-44BE-A80E-BDAD82545781}"/>
              </a:ext>
            </a:extLst>
          </p:cNvPr>
          <p:cNvSpPr txBox="1"/>
          <p:nvPr/>
        </p:nvSpPr>
        <p:spPr>
          <a:xfrm>
            <a:off x="328639" y="312536"/>
            <a:ext cx="22733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.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 rot="16200000">
            <a:off x="5927321" y="2124120"/>
            <a:ext cx="7328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 rot="16200000">
            <a:off x="6126315" y="1963243"/>
            <a:ext cx="10546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riamteren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838466" y="5584636"/>
            <a:ext cx="6846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CTA1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838466" y="3297356"/>
            <a:ext cx="6126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C3-II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838466" y="3017729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C3-I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5207580" y="2124120"/>
            <a:ext cx="7328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5406574" y="1963243"/>
            <a:ext cx="10546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riamteren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직선 연결선 9"/>
          <p:cNvCxnSpPr/>
          <p:nvPr/>
        </p:nvCxnSpPr>
        <p:spPr>
          <a:xfrm flipH="1">
            <a:off x="6115207" y="1536729"/>
            <a:ext cx="67955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6026116" y="1259377"/>
            <a:ext cx="8577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TG5 KO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직선 연결선 11"/>
          <p:cNvCxnSpPr/>
          <p:nvPr/>
        </p:nvCxnSpPr>
        <p:spPr>
          <a:xfrm flipH="1">
            <a:off x="5355452" y="1536729"/>
            <a:ext cx="67955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5482669" y="1259377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838466" y="2662830"/>
            <a:ext cx="804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TG5-12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6838466" y="3634935"/>
            <a:ext cx="7056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LAMP1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838466" y="4027269"/>
            <a:ext cx="9525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P4HB (ER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838466" y="4406766"/>
            <a:ext cx="1136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FTCD (Golgi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838466" y="4800821"/>
            <a:ext cx="12863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OMM20 (Mito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838466" y="5190581"/>
            <a:ext cx="1327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BCD3 (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eroxi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그림 19"/>
          <p:cNvPicPr preferRelativeResize="0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3703" y="4761990"/>
            <a:ext cx="1440000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그림 20"/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3703" y="5153194"/>
            <a:ext cx="1440000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그림 21"/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3703" y="3979582"/>
            <a:ext cx="1440000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그림 22"/>
          <p:cNvPicPr preferRelativeResize="0"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3703" y="4370786"/>
            <a:ext cx="1440000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그림 23"/>
          <p:cNvPicPr preferRelativeResize="0"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3703" y="3017174"/>
            <a:ext cx="14400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그림 24"/>
          <p:cNvPicPr preferRelativeResize="0"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3703" y="5550231"/>
            <a:ext cx="1440000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그림 25"/>
          <p:cNvPicPr preferRelativeResize="0"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3703" y="3588378"/>
            <a:ext cx="1440000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그림 26"/>
          <p:cNvPicPr preferRelativeResize="0">
            <a:picLocks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7466" b="7280"/>
          <a:stretch/>
        </p:blipFill>
        <p:spPr>
          <a:xfrm>
            <a:off x="5393703" y="2625970"/>
            <a:ext cx="1440000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40620619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그룹 10"/>
          <p:cNvGrpSpPr>
            <a:grpSpLocks/>
          </p:cNvGrpSpPr>
          <p:nvPr/>
        </p:nvGrpSpPr>
        <p:grpSpPr>
          <a:xfrm>
            <a:off x="2354233" y="1845213"/>
            <a:ext cx="1800000" cy="1440000"/>
            <a:chOff x="454942" y="294669"/>
            <a:chExt cx="2880000" cy="2160000"/>
          </a:xfrm>
        </p:grpSpPr>
        <p:pic>
          <p:nvPicPr>
            <p:cNvPr id="12" name="그림 11"/>
            <p:cNvPicPr preferRelativeResize="0">
              <a:picLocks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476" t="52250" r="11845" b="16254"/>
            <a:stretch/>
          </p:blipFill>
          <p:spPr>
            <a:xfrm>
              <a:off x="454942" y="294669"/>
              <a:ext cx="2880000" cy="216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13" name="직선 연결선 12"/>
            <p:cNvCxnSpPr/>
            <p:nvPr/>
          </p:nvCxnSpPr>
          <p:spPr>
            <a:xfrm>
              <a:off x="2980267" y="2345267"/>
              <a:ext cx="2592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8" name="그림 17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450" t="17596" r="35951" b="37784"/>
          <a:stretch/>
        </p:blipFill>
        <p:spPr>
          <a:xfrm>
            <a:off x="2354233" y="3824821"/>
            <a:ext cx="180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" name="TextBox 19"/>
          <p:cNvSpPr txBox="1"/>
          <p:nvPr/>
        </p:nvSpPr>
        <p:spPr>
          <a:xfrm>
            <a:off x="2806834" y="3539030"/>
            <a:ext cx="8947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milorid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그림 20"/>
          <p:cNvPicPr preferRelativeResize="0">
            <a:picLocks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25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3389" t="29955" r="24932" b="38549"/>
          <a:stretch/>
        </p:blipFill>
        <p:spPr>
          <a:xfrm>
            <a:off x="4281267" y="3824821"/>
            <a:ext cx="180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" name="TextBox 21"/>
          <p:cNvSpPr txBox="1"/>
          <p:nvPr/>
        </p:nvSpPr>
        <p:spPr>
          <a:xfrm>
            <a:off x="4635283" y="3539030"/>
            <a:ext cx="1091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minopterin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그림 23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25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160" t="22687" r="34160" b="40568"/>
          <a:stretch/>
        </p:blipFill>
        <p:spPr>
          <a:xfrm>
            <a:off x="6208302" y="3824821"/>
            <a:ext cx="180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0" name="TextBox 29"/>
          <p:cNvSpPr txBox="1"/>
          <p:nvPr/>
        </p:nvSpPr>
        <p:spPr>
          <a:xfrm>
            <a:off x="2626495" y="5385415"/>
            <a:ext cx="12554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ENaC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 inhibitor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직선 연결선 30"/>
          <p:cNvCxnSpPr/>
          <p:nvPr/>
        </p:nvCxnSpPr>
        <p:spPr>
          <a:xfrm>
            <a:off x="4264303" y="5376389"/>
            <a:ext cx="374399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5453262" y="5385415"/>
            <a:ext cx="1366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ntifolate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 drugs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직선 연결선 32"/>
          <p:cNvCxnSpPr/>
          <p:nvPr/>
        </p:nvCxnSpPr>
        <p:spPr>
          <a:xfrm>
            <a:off x="8135337" y="5376389"/>
            <a:ext cx="180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8406803" y="5385415"/>
            <a:ext cx="12570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GR5 inhibitor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그림 35"/>
          <p:cNvPicPr preferRelativeResize="0">
            <a:picLocks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899" t="41328" r="56456" b="16641"/>
          <a:stretch/>
        </p:blipFill>
        <p:spPr>
          <a:xfrm>
            <a:off x="8135336" y="3824820"/>
            <a:ext cx="1800001" cy="144000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7" name="TextBox 36"/>
          <p:cNvSpPr txBox="1"/>
          <p:nvPr/>
        </p:nvSpPr>
        <p:spPr>
          <a:xfrm>
            <a:off x="2887787" y="1556842"/>
            <a:ext cx="7328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827645" y="1556842"/>
            <a:ext cx="7072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LLOM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6580976" y="1556842"/>
            <a:ext cx="10546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riamteren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6581556" y="3539030"/>
            <a:ext cx="10534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emetrexe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8665908" y="3539030"/>
            <a:ext cx="738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BI-115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직선 연결선 43"/>
          <p:cNvCxnSpPr/>
          <p:nvPr/>
        </p:nvCxnSpPr>
        <p:spPr>
          <a:xfrm>
            <a:off x="2354233" y="5376389"/>
            <a:ext cx="180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7" name="그림 46"/>
          <p:cNvPicPr preferRelativeResize="0">
            <a:picLocks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harpenSoften amount="25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401" t="21561" r="33809" b="46916"/>
          <a:stretch/>
        </p:blipFill>
        <p:spPr>
          <a:xfrm>
            <a:off x="4281267" y="1845213"/>
            <a:ext cx="180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8" name="그림 47"/>
          <p:cNvPicPr preferRelativeResize="0">
            <a:picLocks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722" t="62215" r="21593" b="6365"/>
          <a:stretch/>
        </p:blipFill>
        <p:spPr>
          <a:xfrm flipV="1">
            <a:off x="6208301" y="1845213"/>
            <a:ext cx="1800001" cy="144000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1CFE0B25-54A4-42C1-B3C3-DC2EBF466CE1}"/>
              </a:ext>
            </a:extLst>
          </p:cNvPr>
          <p:cNvSpPr txBox="1"/>
          <p:nvPr/>
        </p:nvSpPr>
        <p:spPr>
          <a:xfrm>
            <a:off x="328639" y="312536"/>
            <a:ext cx="22733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.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288009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27</TotalTime>
  <Words>127</Words>
  <Application>Microsoft Office PowerPoint</Application>
  <PresentationFormat>Custom</PresentationFormat>
  <Paragraphs>68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테마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 나연</dc:creator>
  <cp:lastModifiedBy>Suganya T.</cp:lastModifiedBy>
  <cp:revision>285</cp:revision>
  <cp:lastPrinted>2021-04-06T01:41:37Z</cp:lastPrinted>
  <dcterms:created xsi:type="dcterms:W3CDTF">2020-08-07T09:30:34Z</dcterms:created>
  <dcterms:modified xsi:type="dcterms:W3CDTF">2021-05-29T08:12:27Z</dcterms:modified>
</cp:coreProperties>
</file>